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>
        <p:scale>
          <a:sx n="90" d="100"/>
          <a:sy n="90" d="100"/>
        </p:scale>
        <p:origin x="2704" y="-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7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461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584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746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031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224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960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091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877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590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390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730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259F3-529D-4598-A1F9-3C0153FC15C1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5F0E0D-ED8A-4D5A-BC6B-E5A4A3698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504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987E950D-6E60-4437-98CF-CCA3361BD95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590" b="41808"/>
          <a:stretch/>
        </p:blipFill>
        <p:spPr>
          <a:xfrm>
            <a:off x="0" y="1415144"/>
            <a:ext cx="6858000" cy="374468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43739F0C-1088-4495-B0AF-91474709ECB6}"/>
              </a:ext>
            </a:extLst>
          </p:cNvPr>
          <p:cNvSpPr txBox="1"/>
          <p:nvPr/>
        </p:nvSpPr>
        <p:spPr>
          <a:xfrm>
            <a:off x="574552" y="5449483"/>
            <a:ext cx="57716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aphical genotypes of the reciprocal CSSLs of chromosome 5 (a) K-CSSLs, (b) T-CSSLs. Orange regions indicate homozygosity for Koshihikari; blue regions indicate homozygosity for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kanar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97246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35</Words>
  <Application>Microsoft Macintosh PowerPoint</Application>
  <PresentationFormat>A4 210x297 mm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dria Mulsanti</dc:creator>
  <cp:lastModifiedBy>Microsoft Office ユーザー</cp:lastModifiedBy>
  <cp:revision>2</cp:revision>
  <dcterms:created xsi:type="dcterms:W3CDTF">2018-01-26T09:08:59Z</dcterms:created>
  <dcterms:modified xsi:type="dcterms:W3CDTF">2018-03-07T11:14:00Z</dcterms:modified>
</cp:coreProperties>
</file>